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89462-89F2-4FEF-9681-EE7DAB1F0B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15D00-335C-47B3-8140-B74F00C22F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C4E504-9081-4BA8-8BE8-07BA9060D1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35750-92BB-4C6D-98EF-7E823AFAE4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3C95B-3403-40B7-86FE-C3157E472E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D766E9-5FCF-4E46-B089-9ADBBCEC46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5C6EA-9DC5-4249-86F0-C57087EE4C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04BBF-420B-479B-9914-CC3A82C7B8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1091D-3EED-4159-BA27-D1AE1D5104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842C60-F6D4-432C-9B69-5C857ED04B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70AFA-0A71-4AE6-86A1-735AF24108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2DBC5-0C38-46D0-84B2-CAA5716183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705627-A40E-4007-B443-011CFDB8463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11120" y="762120"/>
            <a:ext cx="6600960" cy="3447360"/>
            <a:chOff x="411120" y="762120"/>
            <a:chExt cx="6600960" cy="3447360"/>
          </a:xfrm>
        </p:grpSpPr>
        <p:grpSp>
          <p:nvGrpSpPr>
            <p:cNvPr id="42" name=""/>
            <p:cNvGrpSpPr/>
            <p:nvPr/>
          </p:nvGrpSpPr>
          <p:grpSpPr>
            <a:xfrm>
              <a:off x="1168200" y="3398760"/>
              <a:ext cx="5594400" cy="402840"/>
              <a:chOff x="1168200" y="3398760"/>
              <a:chExt cx="5594400" cy="402840"/>
            </a:xfrm>
          </p:grpSpPr>
          <p:sp>
            <p:nvSpPr>
              <p:cNvPr id="43" name=""/>
              <p:cNvSpPr/>
              <p:nvPr/>
            </p:nvSpPr>
            <p:spPr>
              <a:xfrm>
                <a:off x="1168200" y="3471840"/>
                <a:ext cx="5594400" cy="3297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2325600" y="3398760"/>
                <a:ext cx="0" cy="40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5122800" y="3398760"/>
                <a:ext cx="0" cy="40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" name=""/>
            <p:cNvSpPr/>
            <p:nvPr/>
          </p:nvSpPr>
          <p:spPr>
            <a:xfrm>
              <a:off x="1508040" y="2428920"/>
              <a:ext cx="800280" cy="91404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H="1">
              <a:off x="5165280" y="2352600"/>
              <a:ext cx="1143000" cy="91404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8" name=""/>
            <p:cNvGrpSpPr/>
            <p:nvPr/>
          </p:nvGrpSpPr>
          <p:grpSpPr>
            <a:xfrm>
              <a:off x="1165320" y="1604880"/>
              <a:ext cx="5600520" cy="685440"/>
              <a:chOff x="1165320" y="1604880"/>
              <a:chExt cx="5600520" cy="685440"/>
            </a:xfrm>
          </p:grpSpPr>
          <p:sp>
            <p:nvSpPr>
              <p:cNvPr id="49" name=""/>
              <p:cNvSpPr/>
              <p:nvPr/>
            </p:nvSpPr>
            <p:spPr>
              <a:xfrm>
                <a:off x="1165320" y="1776240"/>
                <a:ext cx="5600520" cy="5140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1937520" y="1604880"/>
                <a:ext cx="0" cy="68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5607000" y="1604880"/>
                <a:ext cx="0" cy="34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6283080" y="1604880"/>
                <a:ext cx="0" cy="68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675960" y="1776240"/>
                <a:ext cx="0" cy="51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158720" y="1776240"/>
                <a:ext cx="0" cy="51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454760" y="1604880"/>
                <a:ext cx="0" cy="68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" name=""/>
            <p:cNvSpPr/>
            <p:nvPr/>
          </p:nvSpPr>
          <p:spPr>
            <a:xfrm>
              <a:off x="876240" y="1057320"/>
              <a:ext cx="6135840" cy="85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285840"/>
                  <a:tab algn="l" pos="857160"/>
                  <a:tab algn="l" pos="4857840"/>
                  <a:tab algn="l" pos="59436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Fabs in vectors PAX243hGK and PAX243hG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285840"/>
                  <a:tab algn="l" pos="857160"/>
                  <a:tab algn="l" pos="4857840"/>
                  <a:tab algn="l" pos="59436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285840"/>
                  <a:tab algn="l" pos="857160"/>
                  <a:tab algn="l" pos="4857840"/>
                  <a:tab algn="l" pos="59436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285840"/>
                  <a:tab algn="l" pos="857160"/>
                  <a:tab algn="l" pos="4857840"/>
                  <a:tab algn="l" pos="59436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   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Eco RI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 Xba I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                                                                                             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ge I (Pin AI)   Spe I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285840"/>
                  <a:tab algn="l" pos="857160"/>
                  <a:tab algn="l" pos="4857840"/>
                  <a:tab algn="l" pos="59436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884520" y="1658160"/>
              <a:ext cx="5203080" cy="840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1680"/>
                  <a:tab algn="l" pos="1028880"/>
                  <a:tab algn="l" pos="32576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571680"/>
                  <a:tab algn="l" pos="1028880"/>
                  <a:tab algn="l" pos="32576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571680"/>
                  <a:tab algn="l" pos="1028880"/>
                  <a:tab algn="l" pos="32576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                                      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ight chain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	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                  Heavy chai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571680"/>
                  <a:tab algn="l" pos="1028880"/>
                  <a:tab algn="l" pos="32576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    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mpA           variable/constant region          Pel B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	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      variable/IgG CH1 partial hing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571680"/>
                  <a:tab algn="l" pos="1028880"/>
                  <a:tab algn="l" pos="32576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20000" y="2883600"/>
              <a:ext cx="467496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57480"/>
                  <a:tab algn="l" pos="4800600"/>
                  <a:tab algn="l" pos="58294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                                                                             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257480"/>
                  <a:tab algn="l" pos="4800600"/>
                  <a:tab algn="l" pos="58294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                                       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257480"/>
                  <a:tab algn="l" pos="4800600"/>
                  <a:tab algn="l" pos="58294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                                          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co RI                                                                   Spe 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1257480"/>
                  <a:tab algn="l" pos="4800600"/>
                  <a:tab algn="l" pos="58294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880200" y="3186720"/>
              <a:ext cx="2983320" cy="1022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2629080"/>
                  <a:tab algn="l" pos="422928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2629080"/>
                  <a:tab algn="l" pos="422928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2629080"/>
                  <a:tab algn="l" pos="422928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                                                              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Stuff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2629080"/>
                  <a:tab algn="l" pos="422928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2629080"/>
                  <a:tab algn="l" pos="422928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2629080"/>
                  <a:tab algn="l" pos="422928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xpression vector PAEV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11120" y="7621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" name=""/>
          <p:cNvGrpSpPr/>
          <p:nvPr/>
        </p:nvGrpSpPr>
        <p:grpSpPr>
          <a:xfrm>
            <a:off x="306360" y="4457880"/>
            <a:ext cx="6667200" cy="3924360"/>
            <a:chOff x="306360" y="4457880"/>
            <a:chExt cx="6667200" cy="3924360"/>
          </a:xfrm>
        </p:grpSpPr>
        <p:sp>
          <p:nvSpPr>
            <p:cNvPr id="62" name=""/>
            <p:cNvSpPr/>
            <p:nvPr/>
          </p:nvSpPr>
          <p:spPr>
            <a:xfrm>
              <a:off x="863640" y="5470560"/>
              <a:ext cx="5828760" cy="4708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092240" y="5241960"/>
              <a:ext cx="0" cy="68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663560" y="5241960"/>
              <a:ext cx="0" cy="68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378240" y="5470560"/>
              <a:ext cx="0" cy="456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949560" y="5470560"/>
              <a:ext cx="0" cy="456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778360" y="5270400"/>
              <a:ext cx="0" cy="35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453000" y="5241960"/>
              <a:ext cx="0" cy="68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006640" y="5203800"/>
              <a:ext cx="0" cy="342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869760" y="7304040"/>
              <a:ext cx="5822640" cy="4521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098360" y="7183440"/>
              <a:ext cx="0" cy="57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555560" y="7188120"/>
              <a:ext cx="0" cy="57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6006960" y="7183440"/>
              <a:ext cx="0" cy="228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6464160" y="7183440"/>
              <a:ext cx="0" cy="57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378240" y="7302240"/>
              <a:ext cx="0" cy="456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949560" y="7302240"/>
              <a:ext cx="0" cy="456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H="1">
              <a:off x="1555200" y="6046560"/>
              <a:ext cx="107640" cy="83628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778360" y="6046560"/>
              <a:ext cx="228240" cy="83628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816480" y="4751640"/>
              <a:ext cx="41814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Fabs with an internal Eco RI site in vector PAX243hGK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806760" y="5149440"/>
              <a:ext cx="58773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28560"/>
                  <a:tab algn="l" pos="1371600"/>
                  <a:tab algn="l" pos="1714680"/>
                  <a:tab algn="l" pos="4800600"/>
                  <a:tab algn="l" pos="58294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Eco RI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Xba I  Eco RI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                                                                             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ge I (Pin AI)   Spe 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628560"/>
                  <a:tab algn="l" pos="1371600"/>
                  <a:tab algn="l" pos="1714680"/>
                  <a:tab algn="l" pos="4800600"/>
                  <a:tab algn="l" pos="58294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814320" y="5399640"/>
              <a:ext cx="6019560" cy="687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1680"/>
                  <a:tab algn="l" pos="1028880"/>
                  <a:tab algn="l" pos="32576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571680"/>
                  <a:tab algn="l" pos="1028880"/>
                  <a:tab algn="l" pos="32576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OmpA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       Light chain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                                  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Heavy chai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571680"/>
                  <a:tab algn="l" pos="1028880"/>
                  <a:tab algn="l" pos="32576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 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ariable/constant region             Pel B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        variable/IgG CH1 partial hing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571680"/>
                  <a:tab algn="l" pos="1028880"/>
                  <a:tab algn="l" pos="325764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807840" y="6292080"/>
              <a:ext cx="6165720" cy="1099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1360"/>
                  <a:tab algn="l" pos="628560"/>
                  <a:tab algn="l" pos="5200560"/>
                  <a:tab algn="l" pos="62866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br>
                <a:rPr sz="1800"/>
              </a:b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71360"/>
                  <a:tab algn="l" pos="628560"/>
                  <a:tab algn="l" pos="5200560"/>
                  <a:tab algn="l" pos="62866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71360"/>
                  <a:tab algn="l" pos="628560"/>
                  <a:tab algn="l" pos="5200560"/>
                  <a:tab algn="l" pos="62866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Eco RI   Xba I                                                                                                             Age I (PinAI) Spe I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171360"/>
                  <a:tab algn="l" pos="628560"/>
                  <a:tab algn="l" pos="5200560"/>
                  <a:tab algn="l" pos="628668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801360" y="7009560"/>
              <a:ext cx="5235840" cy="1372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8862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          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8862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1828800"/>
                  <a:tab algn="l" pos="38862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OmpA 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L1A7 light chain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                           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L1A7 heavy chai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8862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ariable/constant region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Pel B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                 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ariable/IgG CH1 partial hing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8862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8862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1828800"/>
                  <a:tab algn="l" pos="38862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Vector PAEV1 (containing L1A7 light and heavy chain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828800"/>
                  <a:tab algn="l" pos="38862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MS Mincho"/>
                </a:rPr>
                <a:t>	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06360" y="44578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10T20:23:54Z</dcterms:created>
  <dc:creator>Computing Resources Group</dc:creator>
  <dc:description/>
  <dc:language>en-US</dc:language>
  <cp:lastModifiedBy>Computing Resources Group</cp:lastModifiedBy>
  <dcterms:modified xsi:type="dcterms:W3CDTF">2010-01-19T21:13:02Z</dcterms:modified>
  <cp:revision>5</cp:revision>
  <dc:subject/>
  <dc:title>Slide 1</dc:title>
</cp:coreProperties>
</file>